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02" r:id="rId2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3DE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5620"/>
    <p:restoredTop sz="96810" autoAdjust="0"/>
  </p:normalViewPr>
  <p:slideViewPr>
    <p:cSldViewPr>
      <p:cViewPr>
        <p:scale>
          <a:sx n="57" d="100"/>
          <a:sy n="57" d="100"/>
        </p:scale>
        <p:origin x="-2548" y="-2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CF3AC30-3FD2-457C-B567-4DE32B595440}" type="datetimeFigureOut">
              <a:rPr lang="fr-FR" smtClean="0"/>
              <a:pPr/>
              <a:t>15/08/2017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79450" y="4714875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BF9C788-15C9-48CB-92D9-9D1DE7E8D98A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57137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033CD-58E0-413C-ADE6-29736F6BB4BA}" type="datetime1">
              <a:rPr lang="en-GB" smtClean="0"/>
              <a:pPr/>
              <a:t>15/08/2017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FAC7F-A3FC-4B60-9A22-65A7FAFD201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77CF71-B2D1-4EF2-B7E2-CAAC4E27E99B}" type="datetime1">
              <a:rPr lang="en-GB" smtClean="0"/>
              <a:pPr/>
              <a:t>15/08/2017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FAC7F-A3FC-4B60-9A22-65A7FAFD201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F35942-A8B6-457E-B592-CD2A10AD7912}" type="datetime1">
              <a:rPr lang="en-GB" smtClean="0"/>
              <a:pPr/>
              <a:t>15/08/2017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FAC7F-A3FC-4B60-9A22-65A7FAFD201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6A05D-59F3-4798-B66F-C71631E73234}" type="datetime1">
              <a:rPr lang="en-GB" smtClean="0"/>
              <a:pPr/>
              <a:t>15/08/2017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FAC7F-A3FC-4B60-9A22-65A7FAFD201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F3E57E-DA65-44CC-9B8E-6E21E1DC3F88}" type="datetime1">
              <a:rPr lang="en-GB" smtClean="0"/>
              <a:pPr/>
              <a:t>15/08/2017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FAC7F-A3FC-4B60-9A22-65A7FAFD201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7A2FE9-1F2A-40F9-9668-DA5EC319EBF6}" type="datetime1">
              <a:rPr lang="en-GB" smtClean="0"/>
              <a:pPr/>
              <a:t>15/08/2017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FAC7F-A3FC-4B60-9A22-65A7FAFD201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0BECB2-DCF9-46A9-85AD-0D4FBF51DD8E}" type="datetime1">
              <a:rPr lang="en-GB" smtClean="0"/>
              <a:pPr/>
              <a:t>15/08/2017</a:t>
            </a:fld>
            <a:endParaRPr lang="en-GB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FAC7F-A3FC-4B60-9A22-65A7FAFD201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BB7C0-9D78-4554-9450-545AE058CADE}" type="datetime1">
              <a:rPr lang="en-GB" smtClean="0"/>
              <a:pPr/>
              <a:t>15/08/2017</a:t>
            </a:fld>
            <a:endParaRPr lang="en-GB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FAC7F-A3FC-4B60-9A22-65A7FAFD201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BAA30-3752-4169-871E-C9CBD39D067D}" type="datetime1">
              <a:rPr lang="en-GB" smtClean="0"/>
              <a:pPr/>
              <a:t>15/08/2017</a:t>
            </a:fld>
            <a:endParaRPr lang="en-GB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FAC7F-A3FC-4B60-9A22-65A7FAFD201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9F2965-1312-416B-BF82-C4FBF3EB5174}" type="datetime1">
              <a:rPr lang="en-GB" smtClean="0"/>
              <a:pPr/>
              <a:t>15/08/2017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FAC7F-A3FC-4B60-9A22-65A7FAFD201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E303A7-4B29-42B7-A758-6BEA2A66EB77}" type="datetime1">
              <a:rPr lang="en-GB" smtClean="0"/>
              <a:pPr/>
              <a:t>15/08/2017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FAC7F-A3FC-4B60-9A22-65A7FAFD2019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1C1461-95BE-4580-A085-12349447F75D}" type="datetime1">
              <a:rPr lang="en-GB" smtClean="0"/>
              <a:pPr/>
              <a:t>15/08/2017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BFAC7F-A3FC-4B60-9A22-65A7FAFD2019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Espace réservé du numéro de diapositive 3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FAC7F-A3FC-4B60-9A22-65A7FAFD2019}" type="slidenum">
              <a:rPr lang="en-GB" smtClean="0"/>
              <a:pPr/>
              <a:t>1</a:t>
            </a:fld>
            <a:endParaRPr lang="en-GB"/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96831136"/>
              </p:ext>
            </p:extLst>
          </p:nvPr>
        </p:nvGraphicFramePr>
        <p:xfrm>
          <a:off x="764704" y="1043608"/>
          <a:ext cx="5308650" cy="67256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857375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270645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514350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51435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637580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514350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</a:tblGrid>
              <a:tr h="446912"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</a:rPr>
                        <a:t>GO biological process complete</a:t>
                      </a:r>
                      <a:endParaRPr lang="en-GB" sz="800" b="0" i="0" u="none" strike="noStrike" dirty="0">
                        <a:solidFill>
                          <a:srgbClr val="0000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u="none" strike="noStrike" dirty="0" smtClean="0">
                          <a:effectLst/>
                        </a:rPr>
                        <a:t>Arabidopsis thaliana (REF)</a:t>
                      </a:r>
                      <a:endParaRPr lang="en-GB" sz="800" b="0" i="0" u="none" strike="noStrike" dirty="0" smtClean="0">
                        <a:solidFill>
                          <a:srgbClr val="0000FF"/>
                        </a:solidFill>
                        <a:effectLst/>
                        <a:latin typeface="Arial" panose="020B0604020202020204" pitchFamily="34" charset="0"/>
                      </a:endParaRPr>
                    </a:p>
                    <a:p>
                      <a:pPr algn="ctr" fontAlgn="t"/>
                      <a:r>
                        <a:rPr lang="en-GB" sz="800" u="none" strike="noStrike" dirty="0" smtClean="0">
                          <a:effectLst/>
                        </a:rPr>
                        <a:t> #</a:t>
                      </a:r>
                      <a:endParaRPr lang="en-GB" sz="800" b="0" i="0" u="none" strike="noStrike" dirty="0">
                        <a:solidFill>
                          <a:srgbClr val="0000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 smtClean="0">
                          <a:effectLst/>
                        </a:rPr>
                        <a:t>Observed</a:t>
                      </a:r>
                    </a:p>
                    <a:p>
                      <a:pPr algn="ctr" fontAlgn="t"/>
                      <a:r>
                        <a:rPr lang="en-GB" sz="800" u="none" strike="noStrike" dirty="0" smtClean="0">
                          <a:effectLst/>
                        </a:rPr>
                        <a:t>#</a:t>
                      </a:r>
                      <a:endParaRPr lang="en-GB" sz="800" b="0" i="0" u="none" strike="noStrike" dirty="0">
                        <a:solidFill>
                          <a:srgbClr val="0000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 smtClean="0">
                          <a:effectLst/>
                        </a:rPr>
                        <a:t>Expected</a:t>
                      </a:r>
                    </a:p>
                    <a:p>
                      <a:pPr algn="ctr" fontAlgn="t"/>
                      <a:r>
                        <a:rPr lang="en-GB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#</a:t>
                      </a:r>
                      <a:endParaRPr lang="en-GB" sz="8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GB" sz="800" u="none" strike="noStrike" dirty="0">
                          <a:effectLst/>
                        </a:rPr>
                        <a:t>Fold Enrichment</a:t>
                      </a:r>
                      <a:endParaRPr lang="en-GB" sz="800" b="0" i="0" u="none" strike="noStrike" dirty="0">
                        <a:solidFill>
                          <a:srgbClr val="0000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>
                          <a:effectLst/>
                        </a:rPr>
                        <a:t>P value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225648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 err="1">
                          <a:effectLst/>
                        </a:rPr>
                        <a:t>defense</a:t>
                      </a:r>
                      <a:r>
                        <a:rPr lang="en-GB" sz="800" u="none" strike="noStrike" dirty="0">
                          <a:effectLst/>
                        </a:rPr>
                        <a:t> response (GO:0006952)</a:t>
                      </a:r>
                      <a:endParaRPr lang="en-GB" sz="800" b="0" i="0" u="none" strike="noStrike" dirty="0">
                        <a:solidFill>
                          <a:srgbClr val="0000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 smtClean="0">
                          <a:effectLst/>
                        </a:rPr>
                        <a:t>1176</a:t>
                      </a:r>
                      <a:endParaRPr lang="en-GB" sz="800" b="0" i="0" u="none" strike="noStrike" dirty="0">
                        <a:solidFill>
                          <a:srgbClr val="0000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</a:rPr>
                        <a:t>33</a:t>
                      </a:r>
                      <a:endParaRPr lang="en-GB" sz="800" b="0" i="0" u="none" strike="noStrike" dirty="0">
                        <a:solidFill>
                          <a:srgbClr val="0000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 smtClean="0">
                          <a:effectLst/>
                        </a:rPr>
                        <a:t>11.7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</a:rPr>
                        <a:t>2.82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u="none" strike="noStrike" dirty="0" smtClean="0">
                          <a:effectLst/>
                        </a:rPr>
                        <a:t>2.23E-04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3974917" y="179512"/>
            <a:ext cx="28351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upplementary Table </a:t>
            </a:r>
            <a:r>
              <a:rPr lang="en-GB" dirty="0" smtClean="0"/>
              <a:t>ST2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8989254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 Classique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157</TotalTime>
  <Words>33</Words>
  <Application>Microsoft Office PowerPoint</Application>
  <PresentationFormat>On-screen Show (4:3)</PresentationFormat>
  <Paragraphs>1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hème Office</vt:lpstr>
      <vt:lpstr>PowerPoint Presentation</vt:lpstr>
    </vt:vector>
  </TitlesOfParts>
  <Company>Université de Genèv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Jean Delatour</dc:creator>
  <cp:lastModifiedBy>Diego Sanchez</cp:lastModifiedBy>
  <cp:revision>1473</cp:revision>
  <dcterms:created xsi:type="dcterms:W3CDTF">2015-09-16T14:04:27Z</dcterms:created>
  <dcterms:modified xsi:type="dcterms:W3CDTF">2017-08-15T17:53:47Z</dcterms:modified>
</cp:coreProperties>
</file>